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94660"/>
  </p:normalViewPr>
  <p:slideViewPr>
    <p:cSldViewPr snapToGrid="0">
      <p:cViewPr varScale="1">
        <p:scale>
          <a:sx n="71" d="100"/>
          <a:sy n="71" d="100"/>
        </p:scale>
        <p:origin x="4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4382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5048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4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369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969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6005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5962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273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772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5554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9016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EB8B51-1F53-4732-981C-E92C1AF45CC6}" type="datetimeFigureOut">
              <a:rPr lang="ko-KR" altLang="en-US" smtClean="0"/>
              <a:t>2019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B0AAE-9C3D-422F-ACBF-55D3290595F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1642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0236500"/>
              </p:ext>
            </p:extLst>
          </p:nvPr>
        </p:nvGraphicFramePr>
        <p:xfrm>
          <a:off x="3513837" y="1374757"/>
          <a:ext cx="4986337" cy="3011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3" imgW="3691031" imgH="2265729" progId="Prism6.Document">
                  <p:embed/>
                </p:oleObj>
              </mc:Choice>
              <mc:Fallback>
                <p:oleObj name="Prism 6" r:id="rId3" imgW="3691031" imgH="226572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13837" y="1374757"/>
                        <a:ext cx="4986337" cy="3011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8039518"/>
              </p:ext>
            </p:extLst>
          </p:nvPr>
        </p:nvGraphicFramePr>
        <p:xfrm>
          <a:off x="3829911" y="4003929"/>
          <a:ext cx="4164059" cy="99218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5754"/>
                <a:gridCol w="671661"/>
                <a:gridCol w="671661"/>
                <a:gridCol w="671661"/>
                <a:gridCol w="671661"/>
                <a:gridCol w="671661"/>
              </a:tblGrid>
              <a:tr h="21667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</a:t>
                      </a:r>
                      <a:r>
                        <a:rPr lang="en-US" altLang="ko-KR" sz="10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ine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3A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Ha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ki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La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180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1667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</a:t>
                      </a:r>
                      <a:r>
                        <a:rPr lang="en-US" altLang="ko-KR" sz="1000" b="1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ype</a:t>
                      </a:r>
                      <a:endParaRPr lang="ko-KR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 Negative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 16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 16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 18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 </a:t>
                      </a:r>
                      <a:r>
                        <a:rPr lang="en-US" altLang="ko-KR" sz="10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,</a:t>
                      </a:r>
                    </a:p>
                    <a:p>
                      <a:pPr algn="ctr" latinLnBrk="1"/>
                      <a:r>
                        <a:rPr lang="en-US" altLang="ko-KR" sz="10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V</a:t>
                      </a:r>
                      <a:r>
                        <a:rPr lang="en-US" altLang="ko-KR" sz="1000" baseline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0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ko-KR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210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</a:t>
                      </a:r>
                      <a:r>
                        <a:rPr lang="en-US" altLang="ko-KR" sz="1000" b="1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ype</a:t>
                      </a:r>
                      <a:endParaRPr lang="ko-KR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</a:t>
                      </a:r>
                      <a:endParaRPr lang="ko-KR" altLang="en-US" sz="9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</a:t>
                      </a:r>
                      <a:endParaRPr lang="ko-KR" altLang="en-US" sz="9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C</a:t>
                      </a:r>
                      <a:endParaRPr lang="ko-KR" altLang="en-US" sz="9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8771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와이드스크린</PresentationFormat>
  <Paragraphs>19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rism 6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ove8875@naver.com</dc:creator>
  <cp:lastModifiedBy>love8875@naver.com</cp:lastModifiedBy>
  <cp:revision>1</cp:revision>
  <dcterms:created xsi:type="dcterms:W3CDTF">2019-02-08T02:41:42Z</dcterms:created>
  <dcterms:modified xsi:type="dcterms:W3CDTF">2019-02-08T02:41:58Z</dcterms:modified>
</cp:coreProperties>
</file>